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94694"/>
  </p:normalViewPr>
  <p:slideViewPr>
    <p:cSldViewPr snapToGrid="0">
      <p:cViewPr varScale="1">
        <p:scale>
          <a:sx n="78" d="100"/>
          <a:sy n="78" d="100"/>
        </p:scale>
        <p:origin x="850"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5D5B37-3CF5-5CB7-891B-8DE0C9F469C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8436C49-1CC3-58A0-20D9-EF1CA4E1741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D933DC1-FEA6-1FD4-10D8-D498C3A27BCB}"/>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5" name="Footer Placeholder 4">
            <a:extLst>
              <a:ext uri="{FF2B5EF4-FFF2-40B4-BE49-F238E27FC236}">
                <a16:creationId xmlns:a16="http://schemas.microsoft.com/office/drawing/2014/main" id="{C56C4CF1-F79C-3E4D-1367-6AADBEC503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0CCB0E2-CFD8-E041-A3B8-7C263E323F71}"/>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31225569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DA3A2E-6D48-CD85-03A5-0CFD43053D7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021DBA8-85AF-016E-86FD-7C3ECF4EF65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30C942F-F8ED-90AB-CA79-0E0C005039BF}"/>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5" name="Footer Placeholder 4">
            <a:extLst>
              <a:ext uri="{FF2B5EF4-FFF2-40B4-BE49-F238E27FC236}">
                <a16:creationId xmlns:a16="http://schemas.microsoft.com/office/drawing/2014/main" id="{F268BDF0-7699-60F4-C942-AC1B0393DD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F6BD079-E3AA-F938-70D6-95C0F8125AB5}"/>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33846242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F385639-DC5D-E469-40F3-A466BB6D29A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F3BC03E-7E95-773F-68B8-38A43BF5C5F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0A9DC9A-199B-9E50-57E3-9B0E2D25DF34}"/>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5" name="Footer Placeholder 4">
            <a:extLst>
              <a:ext uri="{FF2B5EF4-FFF2-40B4-BE49-F238E27FC236}">
                <a16:creationId xmlns:a16="http://schemas.microsoft.com/office/drawing/2014/main" id="{A4E46916-DAD3-59A0-DCA1-7CEAABFA37A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1CA520E-3EA0-9C91-BAE4-BA7E261AD0E4}"/>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13310519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F30180-3772-2D7F-9F55-AF23EF97B31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9DE59E4-7125-F99F-9788-944D57680CB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4A46570-78C4-0B34-7AAD-EB03B0E12A07}"/>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5" name="Footer Placeholder 4">
            <a:extLst>
              <a:ext uri="{FF2B5EF4-FFF2-40B4-BE49-F238E27FC236}">
                <a16:creationId xmlns:a16="http://schemas.microsoft.com/office/drawing/2014/main" id="{F5496C7B-5028-5885-C452-3D055E5AEF2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45C9943-51F5-1F52-32DD-92D9E220A67F}"/>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37167434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D63B40-53AC-EB13-65A1-24B50270D2B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3F41E50-E6B5-B1DA-B846-B6478C667715}"/>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6014BA7-6FA1-DC8A-0FF9-89121F49F2DE}"/>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5" name="Footer Placeholder 4">
            <a:extLst>
              <a:ext uri="{FF2B5EF4-FFF2-40B4-BE49-F238E27FC236}">
                <a16:creationId xmlns:a16="http://schemas.microsoft.com/office/drawing/2014/main" id="{10538DEF-DFA0-0576-93C0-FF4B089AF8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11DD64-EE9F-C658-4C50-29C7573DCC03}"/>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28329891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D94C40-F191-C277-BE62-D2E0CC665E4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4A43534-8D2B-2E5F-5D43-246CF17114F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7C4648B-30B2-4836-ADE1-22D2A41D0C2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2191DD8-4635-45E6-16E0-1F85D5B83614}"/>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6" name="Footer Placeholder 5">
            <a:extLst>
              <a:ext uri="{FF2B5EF4-FFF2-40B4-BE49-F238E27FC236}">
                <a16:creationId xmlns:a16="http://schemas.microsoft.com/office/drawing/2014/main" id="{79D014BA-267F-6567-638B-11BA1A434EC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3E87233-53BD-3C31-2C7E-B2A7A7295F26}"/>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33716412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4FE69F-39F2-1CE3-F048-5DB8DF12965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C930642-35AD-3924-7954-5A553804AE8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B3FAD56-7F03-B9B2-832A-8313815909C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ED4A42E-92EC-04B0-5601-6898D0CF5D9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E9A3D4F-90F3-8047-9C23-90C77F85B5D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C4C650D-99DE-1F2F-D779-057DB8DBDA2E}"/>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8" name="Footer Placeholder 7">
            <a:extLst>
              <a:ext uri="{FF2B5EF4-FFF2-40B4-BE49-F238E27FC236}">
                <a16:creationId xmlns:a16="http://schemas.microsoft.com/office/drawing/2014/main" id="{63AAA6FA-1CF5-55F9-10A2-0DA6D8A9136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555D3D2-51DE-0414-4BDA-A998287A280A}"/>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36306884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6D1237-BD70-1D6C-BD6F-B8CFD60CC46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C9E7BDD-D74C-BCF5-B472-13D245A744FC}"/>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4" name="Footer Placeholder 3">
            <a:extLst>
              <a:ext uri="{FF2B5EF4-FFF2-40B4-BE49-F238E27FC236}">
                <a16:creationId xmlns:a16="http://schemas.microsoft.com/office/drawing/2014/main" id="{ADDE66BD-D197-5F79-8729-7A46AA07F92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05168CF-10F7-23B5-4D64-9E011F45B4FD}"/>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40780494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EB7C023-DFA2-C717-1B3C-BFF67E718C2E}"/>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3" name="Footer Placeholder 2">
            <a:extLst>
              <a:ext uri="{FF2B5EF4-FFF2-40B4-BE49-F238E27FC236}">
                <a16:creationId xmlns:a16="http://schemas.microsoft.com/office/drawing/2014/main" id="{23FEDE2A-01FE-813D-0675-44431F48DDA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C166B93-3995-F99C-2ABB-38B56B54D0F3}"/>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4071913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FEE694-4D0F-2A0E-E80D-6BC846C7BB0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28663F8-DDA9-E9E6-D804-8CA4E404BA9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39BF680-AF65-0767-905A-D343A418809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7C6E6EB-1791-D4D5-98A8-8F615A62C495}"/>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6" name="Footer Placeholder 5">
            <a:extLst>
              <a:ext uri="{FF2B5EF4-FFF2-40B4-BE49-F238E27FC236}">
                <a16:creationId xmlns:a16="http://schemas.microsoft.com/office/drawing/2014/main" id="{71A8DD1B-3F71-CD5F-B529-A87FF8F69F8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3AD767C-60E3-0C5D-81C5-E77A1904D738}"/>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13602682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E9CB2E-1722-2D7C-3930-55C343EE22A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484982F-D908-F69D-042D-DFD0223C4C4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16E0D83-25F4-B72F-E134-A5362986114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AF9F3A7-A944-407C-4715-5E12F1E2EF15}"/>
              </a:ext>
            </a:extLst>
          </p:cNvPr>
          <p:cNvSpPr>
            <a:spLocks noGrp="1"/>
          </p:cNvSpPr>
          <p:nvPr>
            <p:ph type="dt" sz="half" idx="10"/>
          </p:nvPr>
        </p:nvSpPr>
        <p:spPr/>
        <p:txBody>
          <a:bodyPr/>
          <a:lstStyle/>
          <a:p>
            <a:fld id="{6E8B407F-9A35-1E44-996E-537349D217A1}" type="datetimeFigureOut">
              <a:rPr lang="en-US" smtClean="0"/>
              <a:t>2025-10-17</a:t>
            </a:fld>
            <a:endParaRPr lang="en-US"/>
          </a:p>
        </p:txBody>
      </p:sp>
      <p:sp>
        <p:nvSpPr>
          <p:cNvPr id="6" name="Footer Placeholder 5">
            <a:extLst>
              <a:ext uri="{FF2B5EF4-FFF2-40B4-BE49-F238E27FC236}">
                <a16:creationId xmlns:a16="http://schemas.microsoft.com/office/drawing/2014/main" id="{392E9C76-111A-AFFB-D9A0-C9D54705BE9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4655ABF-FCEE-AE60-C6BA-A82792B7646E}"/>
              </a:ext>
            </a:extLst>
          </p:cNvPr>
          <p:cNvSpPr>
            <a:spLocks noGrp="1"/>
          </p:cNvSpPr>
          <p:nvPr>
            <p:ph type="sldNum" sz="quarter" idx="12"/>
          </p:nvPr>
        </p:nvSpPr>
        <p:spPr/>
        <p:txBody>
          <a:bodyPr/>
          <a:lstStyle/>
          <a:p>
            <a:fld id="{4E57E125-897B-8943-8DE7-9549F1BB2A19}" type="slidenum">
              <a:rPr lang="en-US" smtClean="0"/>
              <a:t>‹#›</a:t>
            </a:fld>
            <a:endParaRPr lang="en-US"/>
          </a:p>
        </p:txBody>
      </p:sp>
    </p:spTree>
    <p:extLst>
      <p:ext uri="{BB962C8B-B14F-4D97-AF65-F5344CB8AC3E}">
        <p14:creationId xmlns:p14="http://schemas.microsoft.com/office/powerpoint/2010/main" val="26416726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CE0EEAA-78D0-DE58-C8BC-8CC31B70A03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F326442-4F51-0E55-F7E0-BB97FE4F555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7A35786-6940-08AA-D752-B20D8DEDAD8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6E8B407F-9A35-1E44-996E-537349D217A1}" type="datetimeFigureOut">
              <a:rPr lang="en-US" smtClean="0"/>
              <a:t>2025-10-17</a:t>
            </a:fld>
            <a:endParaRPr lang="en-US"/>
          </a:p>
        </p:txBody>
      </p:sp>
      <p:sp>
        <p:nvSpPr>
          <p:cNvPr id="5" name="Footer Placeholder 4">
            <a:extLst>
              <a:ext uri="{FF2B5EF4-FFF2-40B4-BE49-F238E27FC236}">
                <a16:creationId xmlns:a16="http://schemas.microsoft.com/office/drawing/2014/main" id="{10899204-76D9-28F3-6876-0ACCF6A8096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6CF70CC7-E885-302D-B9DB-07BB532343E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E57E125-897B-8943-8DE7-9549F1BB2A19}" type="slidenum">
              <a:rPr lang="en-US" smtClean="0"/>
              <a:t>‹#›</a:t>
            </a:fld>
            <a:endParaRPr lang="en-US"/>
          </a:p>
        </p:txBody>
      </p:sp>
    </p:spTree>
    <p:extLst>
      <p:ext uri="{BB962C8B-B14F-4D97-AF65-F5344CB8AC3E}">
        <p14:creationId xmlns:p14="http://schemas.microsoft.com/office/powerpoint/2010/main" val="21337758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33E6FE3D-F222-EE4E-819D-D20625AA27AB}"/>
              </a:ext>
            </a:extLst>
          </p:cNvPr>
          <p:cNvPicPr>
            <a:picLocks noChangeAspect="1"/>
          </p:cNvPicPr>
          <p:nvPr/>
        </p:nvPicPr>
        <p:blipFill>
          <a:blip r:embed="rId2"/>
          <a:stretch>
            <a:fillRect/>
          </a:stretch>
        </p:blipFill>
        <p:spPr>
          <a:xfrm>
            <a:off x="3834714" y="290384"/>
            <a:ext cx="7772400" cy="4663440"/>
          </a:xfrm>
          <a:prstGeom prst="rect">
            <a:avLst/>
          </a:prstGeom>
        </p:spPr>
      </p:pic>
      <p:sp>
        <p:nvSpPr>
          <p:cNvPr id="8" name="TextBox 7">
            <a:extLst>
              <a:ext uri="{FF2B5EF4-FFF2-40B4-BE49-F238E27FC236}">
                <a16:creationId xmlns:a16="http://schemas.microsoft.com/office/drawing/2014/main" id="{83C7F468-8469-FF13-48BB-58E02EB4B917}"/>
              </a:ext>
            </a:extLst>
          </p:cNvPr>
          <p:cNvSpPr txBox="1"/>
          <p:nvPr/>
        </p:nvSpPr>
        <p:spPr>
          <a:xfrm>
            <a:off x="2081048" y="5217108"/>
            <a:ext cx="8837919" cy="784830"/>
          </a:xfrm>
          <a:prstGeom prst="rect">
            <a:avLst/>
          </a:prstGeom>
          <a:noFill/>
        </p:spPr>
        <p:txBody>
          <a:bodyPr wrap="square" rtlCol="0">
            <a:spAutoFit/>
          </a:bodyPr>
          <a:lstStyle/>
          <a:p>
            <a:r>
              <a:rPr lang="en-US" sz="900" b="1"/>
              <a:t>Figure S2</a:t>
            </a:r>
            <a:r>
              <a:rPr lang="en-US" sz="900" dirty="0"/>
              <a:t>. Rarefaction curves of microbial diversity illustrating the relationship between sequencing depth (number of reads) and the observed ASVs richness within microbial communities associated with host organisms. Each curve corresponds to an individual sample, and the dotted vertical line at 400,000 reads serves as a reference point for comparing diversity across samples at similar sequencing depths. The plateauing of the curves indicates that an adequate sequencing depth has been achieved to capture the majority of microbial diversity in most samples.</a:t>
            </a:r>
          </a:p>
          <a:p>
            <a:endParaRPr lang="en-US" sz="900" dirty="0"/>
          </a:p>
        </p:txBody>
      </p:sp>
    </p:spTree>
    <p:extLst>
      <p:ext uri="{BB962C8B-B14F-4D97-AF65-F5344CB8AC3E}">
        <p14:creationId xmlns:p14="http://schemas.microsoft.com/office/powerpoint/2010/main" val="12186505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TotalTime>
  <Words>88</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osea Masaki</dc:creator>
  <cp:lastModifiedBy>MDPI</cp:lastModifiedBy>
  <cp:revision>2</cp:revision>
  <dcterms:created xsi:type="dcterms:W3CDTF">2025-09-25T11:20:19Z</dcterms:created>
  <dcterms:modified xsi:type="dcterms:W3CDTF">2025-10-17T14:35:18Z</dcterms:modified>
</cp:coreProperties>
</file>